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57" d="100"/>
          <a:sy n="57" d="100"/>
        </p:scale>
        <p:origin x="184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775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694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379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48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159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191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28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409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505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258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620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B009C-5E1C-42F3-9E0A-02481A316E5E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2705AF-3970-493E-8440-BD4FD8EB0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406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7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2" t="11181" r="5573" b="21034"/>
          <a:stretch/>
        </p:blipFill>
        <p:spPr>
          <a:xfrm>
            <a:off x="4041421" y="316932"/>
            <a:ext cx="2698591" cy="2190045"/>
          </a:xfrm>
          <a:prstGeom prst="rect">
            <a:avLst/>
          </a:prstGeom>
        </p:spPr>
      </p:pic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84" t="11111" r="6042" b="20000"/>
          <a:stretch/>
        </p:blipFill>
        <p:spPr>
          <a:xfrm>
            <a:off x="484914" y="351160"/>
            <a:ext cx="2665079" cy="2183726"/>
          </a:xfrm>
          <a:prstGeom prst="rect">
            <a:avLst/>
          </a:prstGeom>
        </p:spPr>
      </p:pic>
      <p:sp>
        <p:nvSpPr>
          <p:cNvPr id="61" name="TextBox 60"/>
          <p:cNvSpPr txBox="1"/>
          <p:nvPr/>
        </p:nvSpPr>
        <p:spPr>
          <a:xfrm>
            <a:off x="-1559" y="195000"/>
            <a:ext cx="3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438719" y="201431"/>
            <a:ext cx="3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0" y="0"/>
            <a:ext cx="401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ie, et al;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31273" y="2495238"/>
            <a:ext cx="29926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           50          100         150        200         250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ime, month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977830" y="2486855"/>
            <a:ext cx="29926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           50          100         150        200         250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ime, month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02516" y="170112"/>
            <a:ext cx="385666" cy="2333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6200000">
            <a:off x="-859520" y="1293992"/>
            <a:ext cx="20628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757035" y="154415"/>
            <a:ext cx="385666" cy="2333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>
              <a:lnSpc>
                <a:spcPts val="3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2677732" y="1276724"/>
            <a:ext cx="2097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614049" y="862590"/>
            <a:ext cx="471369" cy="12080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25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r">
              <a:lnSpc>
                <a:spcPts val="25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>
              <a:lnSpc>
                <a:spcPts val="25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6200000">
            <a:off x="1337222" y="1079788"/>
            <a:ext cx="897978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R65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700909" y="613397"/>
            <a:ext cx="480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×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180661" y="860676"/>
            <a:ext cx="471369" cy="1220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9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r">
              <a:lnSpc>
                <a:spcPts val="19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r">
              <a:lnSpc>
                <a:spcPts val="19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9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6200000">
            <a:off x="4889822" y="1169432"/>
            <a:ext cx="897978" cy="348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FAR4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242230" y="622786"/>
            <a:ext cx="4806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×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4"/>
          <a:srcRect l="10374" t="11427" r="5584" b="14459"/>
          <a:stretch/>
        </p:blipFill>
        <p:spPr>
          <a:xfrm>
            <a:off x="2002231" y="779907"/>
            <a:ext cx="1152728" cy="1016541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5"/>
          <a:srcRect l="10198" t="11728" r="5740" b="14692"/>
          <a:stretch/>
        </p:blipFill>
        <p:spPr>
          <a:xfrm>
            <a:off x="5573486" y="821907"/>
            <a:ext cx="1152982" cy="1009223"/>
          </a:xfrm>
          <a:prstGeom prst="rect">
            <a:avLst/>
          </a:prstGeom>
        </p:spPr>
      </p:pic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6211893"/>
              </p:ext>
            </p:extLst>
          </p:nvPr>
        </p:nvGraphicFramePr>
        <p:xfrm>
          <a:off x="133381" y="2869406"/>
          <a:ext cx="6606630" cy="9715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1105"/>
                <a:gridCol w="1101105"/>
                <a:gridCol w="1101105"/>
                <a:gridCol w="1101105"/>
                <a:gridCol w="1101105"/>
                <a:gridCol w="1101105"/>
              </a:tblGrid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 ov.ca. n=110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 of </a:t>
                      </a:r>
                      <a:r>
                        <a:rPr lang="en-US" sz="1000" b="1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R65</a:t>
                      </a:r>
                      <a:endParaRPr lang="en-US" sz="1000" b="1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 ov.ca. n=6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 of </a:t>
                      </a:r>
                      <a:r>
                        <a:rPr lang="en-US" sz="1000" b="1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FAR4</a:t>
                      </a:r>
                      <a:endParaRPr lang="en-US" sz="1000" b="1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95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857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subject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of subject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857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,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,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3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61564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7</TotalTime>
  <Words>97</Words>
  <Application>Microsoft Office PowerPoint</Application>
  <PresentationFormat>On-screen Show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23</cp:revision>
  <cp:lastPrinted>2017-04-11T18:46:03Z</cp:lastPrinted>
  <dcterms:created xsi:type="dcterms:W3CDTF">2017-04-10T19:41:52Z</dcterms:created>
  <dcterms:modified xsi:type="dcterms:W3CDTF">2018-02-18T02:20:54Z</dcterms:modified>
</cp:coreProperties>
</file>